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3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8C2EB9-92A8-7DD3-6B73-B655857CFD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B5D8EF-84FE-4056-5C15-5153730018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4529B7-79A7-14D9-0DCA-017DA0A0B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9AD2BF-E84E-7BED-558B-026D067CE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F2502F-7D04-5C39-6A3F-49ADF4EBF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78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4D57D-CD77-9ADA-BF9C-894C867683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7F83FD-34AA-7E21-D418-42C3783122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30AD05-83EF-F771-58BE-5A9A4AE9E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4488A8-5C25-A7A0-4DC4-E0D8B78E2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34B48D-3F10-41FF-95BA-89971ED62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595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3EBABE-88D3-A983-9DE3-84F46A3DB5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EEBEC7-9FCE-DC2D-EC0C-86ABB5734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26503E-C1CC-36D7-C5DD-51398804B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60F4AE-E699-6C51-8202-F234FAC7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88F40-6768-3302-CBB3-ACF8D7C16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974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CFB75-9832-1B88-35A2-391B46C1A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470D2D-C050-09FE-2EA6-69FBBAFFFD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4C27D6-D9D0-D0DA-1B9B-E2345C691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408DE2-98B9-6A78-EA35-52CFDF59D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92714-4B7D-F80F-61A4-7EE87025F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454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7B5C34-3100-C62F-7920-CFE591E24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82F216-8831-82F7-2765-375B5FDBE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D95411-5BC1-8AAE-59FA-077B68DF3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832BDD-D126-71AA-D80F-950988FBE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9A8370-448F-478E-DDAC-45699F9E6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816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91C57-1B09-E259-9095-69FFBA55A7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93261A-15EC-1CAA-4AAF-BFAC904348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1193CE-855D-4C7B-155C-C111B80473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758BEA-A4E7-9177-2163-933480FCD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4D435D-CB84-EACA-74D9-7B2A417C2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4C282-EDBD-436E-209F-73E5046B4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803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67436C-CA01-9A15-950B-7686805FE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2EB832-5668-15DA-F559-7C908E61AF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4FD3E9-87D0-7C8D-4296-9B0960D6B8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3CD6DE-B7C6-F559-3441-9ABCB372E9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0F633F-E4D8-A876-8ECD-8667587C0B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7C20EC-4430-996F-8219-1B8680247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CEFB70-6E2C-2747-EE96-566E91369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1ED010-D8D7-2EDA-529E-B470C60AC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490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025F7-D544-D116-6333-472FBCA93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AF910D-E7A6-56B3-C1FB-021F23971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001277-6A2C-7AA6-BCC1-19E44697F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FBA876-2683-128B-B1CE-46C69A8E5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127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333C1D-790E-C009-D964-3DE549E47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F294F1-5E38-AD1D-59CC-53BF9BA6D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C03365-8E59-4BB3-91F4-9F39441BB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194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E3FA4-C8B6-0667-0D61-21F23ABE7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A33531-774F-0062-CFA9-DDC57CFF9F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04ECD3-5138-8E51-D789-2FD34E872D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8E9D44-5BDC-B758-9EB9-D0F463EFB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55ADC5-8CD8-DB6C-B8F2-32461D3A6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89F6E6-9EC6-D305-AE00-C6880A31F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485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4C4C3-8050-E9F3-C691-9DFC67EA5F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BABAEE8-5913-DEB2-6188-C611DB6460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C6CCDA-7CEA-E7B3-F508-F9DD0FD04E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BF61AF-5676-46B9-AD0F-17DD3E928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6E7287-8167-8288-DB51-36F151E9F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4DAA38-CB15-5A20-EB0A-168C87576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011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CE1801-BE7C-D539-C187-1F76C500FD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8967BA-2D8C-FE58-0494-9D3F96EC56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C96AD4-227C-8F93-227B-EC8FFBF9B0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BCF9EE-2E20-4ADE-9ADE-51958C1AA0B1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8B97F-1777-C6D9-6200-5F795B0628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C5D80D-87D1-B4DE-984B-C3E86F6231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D536D7-28DD-4C81-A10E-C357F541E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452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9E20F01-2027-4D02-AEAA-5C81D08700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44189" y="0"/>
            <a:ext cx="3194562" cy="62855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AD9E719-A524-5137-1BD6-54474F8E19C0}"/>
              </a:ext>
            </a:extLst>
          </p:cNvPr>
          <p:cNvSpPr txBox="1"/>
          <p:nvPr/>
        </p:nvSpPr>
        <p:spPr>
          <a:xfrm>
            <a:off x="192504" y="6285551"/>
            <a:ext cx="1187516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Supplementary Figure 2 – Patients treated with BMC with and without PRP booster injections.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Change in outcomes (PROMs) at the 6-, 12- and 24-month follow-ups for DASH (A), NPS (B), and SANE (C) for patients with (n=19) and without (n=25) additional PRP booster injections. Solid lines indicate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chemeClr val="accent4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median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values.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5893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6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hren Dodson</dc:creator>
  <cp:lastModifiedBy>Ehren Dodson</cp:lastModifiedBy>
  <cp:revision>2</cp:revision>
  <dcterms:created xsi:type="dcterms:W3CDTF">2024-04-25T15:55:37Z</dcterms:created>
  <dcterms:modified xsi:type="dcterms:W3CDTF">2024-04-25T16:24:36Z</dcterms:modified>
</cp:coreProperties>
</file>